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631FB-88E8-AC76-C05A-E6678A1945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DE7C513-8AA4-9549-7B0E-3D5D32D3D4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92E740-768F-EF8B-3153-AC2F4AFC6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7CF75-2DEF-E602-D0D8-2A918C97E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C907F-914B-6491-7237-67C26A8E1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35450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FC49B4-F719-F9B6-9C9D-7D29145112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7FEACE-C659-B400-4359-332DF48211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21F3C8-BE0B-BCE9-A8BB-9649B93B41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CC14E0-B261-41D6-53D1-B022CFB7B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AC3CD1-0D53-8019-E364-D774245EBD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310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88EB90A-9DDB-F4FD-D13F-60C2E15707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317998-10D2-F971-AA37-AD61828C87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252AC2-5E6B-7088-24DA-5174C29F0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008E6F-F4F8-1C58-E770-079CE660D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BB570-D7C6-F715-C03B-03104141C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021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097FB6-C1C7-1401-648E-C002161BB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ED95BB-5352-6E1B-86C9-AF59C2E372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F9A169-8EBB-A830-6E22-52E2B7BE0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ABAAEC-86C4-8A0B-8F6C-FF7FD06B9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CC5ABE-FD9F-DF2D-993B-1B5248D58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3163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42B32C-201C-7171-4A9B-894E4636C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F4FB54-ECAE-9373-A5E0-8348112FE6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BDA86-5BD5-8EEA-A018-8A51BA94FE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C0FE30-E956-DF48-C706-5FBD54C71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03698-DB34-C7F6-C6DF-7E9779C3A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7904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7F3E23-2D6F-CDD9-12AC-DD1456EC93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23216E-DFCC-A558-7E7A-28965F0724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59EE6C-F914-7099-A88A-99C02F8818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52FAB-1FAC-FB2E-BC47-8B19AB976A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340C4E4-AF45-2F83-5009-88046027E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9BAC89-1BEA-D4DC-378D-A52A50190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2058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EAB5A-9116-5F55-056E-85713DD4C7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C19EB7-5FCA-3646-BDA3-EABF21F80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656AD2-5B1C-3BC9-7158-0ED5C9D498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02F032-8E97-6741-BF4E-DCAA1CE3E6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033F79-C8FE-0B24-4632-C7F935003C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D694FE-9276-0FD2-389C-8C63A9C061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C8EE733-2499-5E66-4AA1-ED713917F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99AF56-C1CF-E071-D1E1-F674D9DA1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3091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F5AE18-47FB-AB0E-9B5D-4CD832B2BA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0B61695-A515-BE4E-7222-D7A9EBF670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AB4032-4AAB-D186-CCBA-5DC4140E3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6736B7-A489-CC76-97B5-F505D72D5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713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98309F-E3ED-0036-5401-655EB6658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0FEAA5-BCB1-89AE-21CB-781558B31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8FC0CA6-7CBD-6AF5-569B-7627BBECD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563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B906C-F6CE-15B2-87F6-CE2CDDC24C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EF7891-451E-42FB-5D46-ABCDB6E5C5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9734E6-88E5-7585-6C2D-046A0454B1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222DF2-69A1-A7CC-30D2-00A4BC33A6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6DF184-BAFB-CD8E-AABE-79726BB6F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5A44FE-DA2F-4DC3-CDC7-34C7499F57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564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95B66-1ED7-267C-28E1-E5A81CD58D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AD6E2F-B0DE-BF88-08D1-C28910FA27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D5FEC1-0A38-A3B1-F60C-52912BF9BA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4C297E-E1BB-3012-AF3D-7EB2E5782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1AC79B-8307-70AA-93E1-525ED1B93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492FA5-5C73-3B44-F381-322704ACF8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1341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368864-9E61-4A7F-9675-957BEFD5FD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52F061-5E9E-BD41-B852-B189BB3C5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F247C0-E1D1-6457-6EF0-91096A9F47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8FDA96B-EBE4-43B1-ACB1-700A34A82037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640A78-5D64-D4DA-AEA5-8E713AA368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108F2C-5492-0BF0-99BB-2A1BAC5BF0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98414D-B618-4239-BE03-4CFAFD8B51E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5987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5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430CD0E-59E7-1F46-9578-5645ADEF70FD}"/>
              </a:ext>
            </a:extLst>
          </p:cNvPr>
          <p:cNvSpPr txBox="1"/>
          <p:nvPr/>
        </p:nvSpPr>
        <p:spPr>
          <a:xfrm>
            <a:off x="365895" y="3275875"/>
            <a:ext cx="13083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KO HeLa cells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9AF1062-3CE8-B332-BB4C-B6E9D611D94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3898" t="19355" r="19096" b="66105"/>
          <a:stretch/>
        </p:blipFill>
        <p:spPr>
          <a:xfrm rot="5400000">
            <a:off x="741235" y="2197582"/>
            <a:ext cx="368827" cy="9586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34B4A49-CE49-FCF1-31FF-8BED0CE56C7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09" t="17910" r="34837" b="67823"/>
          <a:stretch/>
        </p:blipFill>
        <p:spPr>
          <a:xfrm rot="5400000">
            <a:off x="734555" y="1375904"/>
            <a:ext cx="382188" cy="9586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FC7582F-4BBF-F365-B439-607D201067F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1033" t="25980" r="31113" b="59490"/>
          <a:stretch/>
        </p:blipFill>
        <p:spPr>
          <a:xfrm rot="5400000">
            <a:off x="741235" y="2611762"/>
            <a:ext cx="368827" cy="9586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91D81B8-CCE8-9BB5-B67B-BB14571527C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558" t="24893" r="30625" b="44081"/>
          <a:stretch/>
        </p:blipFill>
        <p:spPr>
          <a:xfrm rot="5400000">
            <a:off x="735087" y="1789550"/>
            <a:ext cx="381121" cy="9586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0DD5089-88B5-AFC6-85A0-7689DCB13D0A}"/>
              </a:ext>
            </a:extLst>
          </p:cNvPr>
          <p:cNvSpPr txBox="1"/>
          <p:nvPr/>
        </p:nvSpPr>
        <p:spPr>
          <a:xfrm>
            <a:off x="1414935" y="175919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ED725E0-4CD0-2832-91B6-AFCC3FC1B389}"/>
              </a:ext>
            </a:extLst>
          </p:cNvPr>
          <p:cNvSpPr txBox="1"/>
          <p:nvPr/>
        </p:nvSpPr>
        <p:spPr>
          <a:xfrm>
            <a:off x="1414935" y="2176004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25918E0-21E0-25A3-94B4-C99B58B0E8FD}"/>
              </a:ext>
            </a:extLst>
          </p:cNvPr>
          <p:cNvSpPr txBox="1"/>
          <p:nvPr/>
        </p:nvSpPr>
        <p:spPr>
          <a:xfrm>
            <a:off x="1414935" y="2592812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26C5B7B-4C24-9B1F-E222-BA3DBF66E6BC}"/>
              </a:ext>
            </a:extLst>
          </p:cNvPr>
          <p:cNvSpPr txBox="1"/>
          <p:nvPr/>
        </p:nvSpPr>
        <p:spPr>
          <a:xfrm>
            <a:off x="1414935" y="3004363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BE47AE7-EA0D-AD29-D043-5FD85E615F0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56" t="50000" r="54456" b="21070"/>
          <a:stretch/>
        </p:blipFill>
        <p:spPr>
          <a:xfrm rot="16200000">
            <a:off x="730077" y="956181"/>
            <a:ext cx="391141" cy="9586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58002E5-A454-E564-6343-60C85AFA1AC3}"/>
              </a:ext>
            </a:extLst>
          </p:cNvPr>
          <p:cNvSpPr txBox="1"/>
          <p:nvPr/>
        </p:nvSpPr>
        <p:spPr>
          <a:xfrm>
            <a:off x="1414935" y="135331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555B058-1A25-6EF2-1670-E4DC814A304A}"/>
              </a:ext>
            </a:extLst>
          </p:cNvPr>
          <p:cNvSpPr txBox="1"/>
          <p:nvPr/>
        </p:nvSpPr>
        <p:spPr>
          <a:xfrm>
            <a:off x="70621" y="5480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DA7BDC3E-0F98-7A1D-3C51-CD5FCAF9B4D5}"/>
              </a:ext>
            </a:extLst>
          </p:cNvPr>
          <p:cNvGrpSpPr/>
          <p:nvPr/>
        </p:nvGrpSpPr>
        <p:grpSpPr>
          <a:xfrm>
            <a:off x="367743" y="701345"/>
            <a:ext cx="1961714" cy="566217"/>
            <a:chOff x="2748869" y="994868"/>
            <a:chExt cx="1783376" cy="566217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21E8898A-00BD-660B-B56A-5147A4E641B1}"/>
                </a:ext>
              </a:extLst>
            </p:cNvPr>
            <p:cNvSpPr txBox="1"/>
            <p:nvPr/>
          </p:nvSpPr>
          <p:spPr>
            <a:xfrm>
              <a:off x="2748869" y="994868"/>
              <a:ext cx="6126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B63FA612-6169-EAA9-9DB6-B8EED93D1C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30123" y="1204471"/>
              <a:ext cx="398674" cy="24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9CA4AD0-4EA4-4106-8DC8-9E5DC9FE674E}"/>
                </a:ext>
              </a:extLst>
            </p:cNvPr>
            <p:cNvSpPr txBox="1"/>
            <p:nvPr/>
          </p:nvSpPr>
          <p:spPr>
            <a:xfrm>
              <a:off x="3236118" y="997863"/>
              <a:ext cx="5966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B57DC6D3-204B-D080-1381-10CA20C7D02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01727" y="1204471"/>
              <a:ext cx="398674" cy="241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48E3362-A0C1-6771-5CA5-1FF6130B7EEE}"/>
                </a:ext>
              </a:extLst>
            </p:cNvPr>
            <p:cNvSpPr txBox="1"/>
            <p:nvPr/>
          </p:nvSpPr>
          <p:spPr>
            <a:xfrm>
              <a:off x="3670704" y="1330253"/>
              <a:ext cx="86154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SP43 sgRN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1EF338E-BEFA-DC07-77A0-5DFB1AB30459}"/>
                </a:ext>
              </a:extLst>
            </p:cNvPr>
            <p:cNvSpPr txBox="1"/>
            <p:nvPr/>
          </p:nvSpPr>
          <p:spPr>
            <a:xfrm>
              <a:off x="3670704" y="1186667"/>
              <a:ext cx="8163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HIF1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 sgRNA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A983C040-116B-5831-D04D-D31992D4EFF9}"/>
                </a:ext>
              </a:extLst>
            </p:cNvPr>
            <p:cNvGrpSpPr/>
            <p:nvPr/>
          </p:nvGrpSpPr>
          <p:grpSpPr>
            <a:xfrm>
              <a:off x="2788186" y="1184059"/>
              <a:ext cx="920162" cy="365781"/>
              <a:chOff x="7623314" y="2229395"/>
              <a:chExt cx="1113395" cy="365781"/>
            </a:xfrm>
          </p:grpSpPr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2F016B80-3A3C-74E2-95A0-81723337F63B}"/>
                  </a:ext>
                </a:extLst>
              </p:cNvPr>
              <p:cNvSpPr txBox="1"/>
              <p:nvPr/>
            </p:nvSpPr>
            <p:spPr>
              <a:xfrm>
                <a:off x="8131631" y="2229395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9E40E1FE-66AA-1F47-6091-7179F3600E03}"/>
                  </a:ext>
                </a:extLst>
              </p:cNvPr>
              <p:cNvSpPr txBox="1"/>
              <p:nvPr/>
            </p:nvSpPr>
            <p:spPr>
              <a:xfrm>
                <a:off x="8283002" y="2229395"/>
                <a:ext cx="2771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FDBF2D9-E8FC-2E3F-95C1-4F455F1A8C15}"/>
                  </a:ext>
                </a:extLst>
              </p:cNvPr>
              <p:cNvSpPr txBox="1"/>
              <p:nvPr/>
            </p:nvSpPr>
            <p:spPr>
              <a:xfrm>
                <a:off x="8467900" y="2229395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4166EF2D-82D2-CA63-9594-1D5652FF3071}"/>
                  </a:ext>
                </a:extLst>
              </p:cNvPr>
              <p:cNvSpPr txBox="1"/>
              <p:nvPr/>
            </p:nvSpPr>
            <p:spPr>
              <a:xfrm>
                <a:off x="8131631" y="2364344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1BB54875-F4A0-3447-4EE1-BFBA103F0D3B}"/>
                  </a:ext>
                </a:extLst>
              </p:cNvPr>
              <p:cNvSpPr txBox="1"/>
              <p:nvPr/>
            </p:nvSpPr>
            <p:spPr>
              <a:xfrm>
                <a:off x="8299766" y="2364344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7C804681-995D-5AC0-A84B-E879EE23B82E}"/>
                  </a:ext>
                </a:extLst>
              </p:cNvPr>
              <p:cNvSpPr txBox="1"/>
              <p:nvPr/>
            </p:nvSpPr>
            <p:spPr>
              <a:xfrm>
                <a:off x="8459518" y="2364344"/>
                <a:ext cx="2771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649CBBD-BBA7-2A02-EB68-D8B96BF10EC4}"/>
                  </a:ext>
                </a:extLst>
              </p:cNvPr>
              <p:cNvSpPr txBox="1"/>
              <p:nvPr/>
            </p:nvSpPr>
            <p:spPr>
              <a:xfrm>
                <a:off x="7623314" y="2229395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8234F5C5-92A6-6C25-E246-2CF5882EF75C}"/>
                  </a:ext>
                </a:extLst>
              </p:cNvPr>
              <p:cNvSpPr txBox="1"/>
              <p:nvPr/>
            </p:nvSpPr>
            <p:spPr>
              <a:xfrm>
                <a:off x="7774685" y="2229395"/>
                <a:ext cx="2771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38240178-D1D4-401F-29F5-0BFEA9B4FE5B}"/>
                  </a:ext>
                </a:extLst>
              </p:cNvPr>
              <p:cNvSpPr txBox="1"/>
              <p:nvPr/>
            </p:nvSpPr>
            <p:spPr>
              <a:xfrm>
                <a:off x="7959583" y="2229395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6B3381A-F4DA-1D9E-529C-949247C321BE}"/>
                  </a:ext>
                </a:extLst>
              </p:cNvPr>
              <p:cNvSpPr txBox="1"/>
              <p:nvPr/>
            </p:nvSpPr>
            <p:spPr>
              <a:xfrm>
                <a:off x="7623314" y="2364344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5FAA79B-17D2-A858-69A5-6700E5034D39}"/>
                  </a:ext>
                </a:extLst>
              </p:cNvPr>
              <p:cNvSpPr txBox="1"/>
              <p:nvPr/>
            </p:nvSpPr>
            <p:spPr>
              <a:xfrm>
                <a:off x="7791449" y="2364344"/>
                <a:ext cx="24545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9004AC48-67B1-2C30-6E9B-CA27EF2CDF81}"/>
                  </a:ext>
                </a:extLst>
              </p:cNvPr>
              <p:cNvSpPr txBox="1"/>
              <p:nvPr/>
            </p:nvSpPr>
            <p:spPr>
              <a:xfrm>
                <a:off x="7951201" y="2364344"/>
                <a:ext cx="27719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</p:grp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4FB17B4A-FF6D-B760-1F39-DB3FDA812F90}"/>
              </a:ext>
            </a:extLst>
          </p:cNvPr>
          <p:cNvSpPr txBox="1"/>
          <p:nvPr/>
        </p:nvSpPr>
        <p:spPr>
          <a:xfrm>
            <a:off x="32492" y="993118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A71C819-9D4C-F289-C086-2BA15EC6D59F}"/>
              </a:ext>
            </a:extLst>
          </p:cNvPr>
          <p:cNvSpPr txBox="1"/>
          <p:nvPr/>
        </p:nvSpPr>
        <p:spPr>
          <a:xfrm>
            <a:off x="42094" y="1199445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0D2A385-6211-DA49-15C3-0A60D2A21A2D}"/>
              </a:ext>
            </a:extLst>
          </p:cNvPr>
          <p:cNvSpPr txBox="1"/>
          <p:nvPr/>
        </p:nvSpPr>
        <p:spPr>
          <a:xfrm>
            <a:off x="90269" y="176305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E30DFBF-A037-9F96-BA71-0B7BFF2DDECA}"/>
              </a:ext>
            </a:extLst>
          </p:cNvPr>
          <p:cNvSpPr txBox="1"/>
          <p:nvPr/>
        </p:nvSpPr>
        <p:spPr>
          <a:xfrm>
            <a:off x="90269" y="266371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C97C9AB3-F09C-904C-FC64-0D2C3BDE14A7}"/>
              </a:ext>
            </a:extLst>
          </p:cNvPr>
          <p:cNvSpPr txBox="1"/>
          <p:nvPr/>
        </p:nvSpPr>
        <p:spPr>
          <a:xfrm>
            <a:off x="90269" y="3118455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9DB10DF-78B9-8FC0-F68E-46A1742AD278}"/>
              </a:ext>
            </a:extLst>
          </p:cNvPr>
          <p:cNvSpPr txBox="1"/>
          <p:nvPr/>
        </p:nvSpPr>
        <p:spPr>
          <a:xfrm>
            <a:off x="90269" y="2119226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054D8B35-C0D8-9A2D-A8A5-0969A99B741A}"/>
              </a:ext>
            </a:extLst>
          </p:cNvPr>
          <p:cNvCxnSpPr/>
          <p:nvPr/>
        </p:nvCxnSpPr>
        <p:spPr>
          <a:xfrm>
            <a:off x="343549" y="131707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90E647EF-C208-E483-B2E5-9CE08657547D}"/>
              </a:ext>
            </a:extLst>
          </p:cNvPr>
          <p:cNvCxnSpPr/>
          <p:nvPr/>
        </p:nvCxnSpPr>
        <p:spPr>
          <a:xfrm>
            <a:off x="343549" y="187337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6F1872FD-A298-470A-B87E-DB4A076FC91E}"/>
              </a:ext>
            </a:extLst>
          </p:cNvPr>
          <p:cNvCxnSpPr/>
          <p:nvPr/>
        </p:nvCxnSpPr>
        <p:spPr>
          <a:xfrm>
            <a:off x="343549" y="223059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FA17EA1-BA98-1A31-36CC-EE9BACBBDC97}"/>
              </a:ext>
            </a:extLst>
          </p:cNvPr>
          <p:cNvCxnSpPr/>
          <p:nvPr/>
        </p:nvCxnSpPr>
        <p:spPr>
          <a:xfrm>
            <a:off x="343549" y="277600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280E46B2-A325-6640-E803-7DD952037DAC}"/>
              </a:ext>
            </a:extLst>
          </p:cNvPr>
          <p:cNvCxnSpPr/>
          <p:nvPr/>
        </p:nvCxnSpPr>
        <p:spPr>
          <a:xfrm>
            <a:off x="343549" y="324004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7" name="Picture 86">
            <a:extLst>
              <a:ext uri="{FF2B5EF4-FFF2-40B4-BE49-F238E27FC236}">
                <a16:creationId xmlns:a16="http://schemas.microsoft.com/office/drawing/2014/main" id="{95305C33-9B88-11BA-9AA3-48D0F17EA26D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" t="1462" r="179" b="-732"/>
          <a:stretch/>
        </p:blipFill>
        <p:spPr>
          <a:xfrm rot="16200000">
            <a:off x="2008779" y="661463"/>
            <a:ext cx="3104995" cy="20424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401161D8-F49E-5F7E-1644-B5A7152BEF3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6" t="-707" r="991" b="650"/>
          <a:stretch/>
        </p:blipFill>
        <p:spPr>
          <a:xfrm rot="5400000">
            <a:off x="4949524" y="-103240"/>
            <a:ext cx="3424905" cy="37949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D0FC4749-DF76-57BC-B783-6AB2EAE3F10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" t="891" r="702" b="1582"/>
          <a:stretch/>
        </p:blipFill>
        <p:spPr>
          <a:xfrm rot="5400000">
            <a:off x="7815844" y="937851"/>
            <a:ext cx="3672228" cy="18710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216F8547-A2EE-E6B4-54A8-79E1477787F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05" t="383" r="-12" b="388"/>
          <a:stretch/>
        </p:blipFill>
        <p:spPr>
          <a:xfrm rot="5400000">
            <a:off x="581823" y="3435939"/>
            <a:ext cx="2984023" cy="36928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A549A02A-7833-E2B6-4DCF-C671068643B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9" t="681" r="465" b="750"/>
          <a:stretch/>
        </p:blipFill>
        <p:spPr>
          <a:xfrm rot="5400000">
            <a:off x="4563205" y="3271242"/>
            <a:ext cx="2634541" cy="36708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2" name="Rectangle 91">
            <a:extLst>
              <a:ext uri="{FF2B5EF4-FFF2-40B4-BE49-F238E27FC236}">
                <a16:creationId xmlns:a16="http://schemas.microsoft.com/office/drawing/2014/main" id="{BEEA0069-4F5E-3DCE-1026-48ABE06DB036}"/>
              </a:ext>
            </a:extLst>
          </p:cNvPr>
          <p:cNvSpPr/>
          <p:nvPr/>
        </p:nvSpPr>
        <p:spPr>
          <a:xfrm>
            <a:off x="3561276" y="1794254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E53FB693-ED38-44FD-1BD3-5570CF1A4807}"/>
              </a:ext>
            </a:extLst>
          </p:cNvPr>
          <p:cNvSpPr/>
          <p:nvPr/>
        </p:nvSpPr>
        <p:spPr>
          <a:xfrm>
            <a:off x="7306332" y="2104563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642477B3-4399-C877-57B9-3E9A0F7EEC64}"/>
              </a:ext>
            </a:extLst>
          </p:cNvPr>
          <p:cNvSpPr/>
          <p:nvPr/>
        </p:nvSpPr>
        <p:spPr>
          <a:xfrm>
            <a:off x="9592332" y="2302116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3B94BEAE-8AFE-7A0F-E7D6-9B2DC2A1C450}"/>
              </a:ext>
            </a:extLst>
          </p:cNvPr>
          <p:cNvSpPr/>
          <p:nvPr/>
        </p:nvSpPr>
        <p:spPr>
          <a:xfrm>
            <a:off x="2724807" y="5969241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DD649473-67E3-0CAD-8705-78CBFF7DBF13}"/>
              </a:ext>
            </a:extLst>
          </p:cNvPr>
          <p:cNvSpPr/>
          <p:nvPr/>
        </p:nvSpPr>
        <p:spPr>
          <a:xfrm>
            <a:off x="6230007" y="5407266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DB5A225-D21F-94EB-DCAE-FF54E955D815}"/>
              </a:ext>
            </a:extLst>
          </p:cNvPr>
          <p:cNvSpPr txBox="1"/>
          <p:nvPr/>
        </p:nvSpPr>
        <p:spPr>
          <a:xfrm>
            <a:off x="4094961" y="1618932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4FBD674B-3BA5-9637-1DB3-438F02CC42EE}"/>
              </a:ext>
            </a:extLst>
          </p:cNvPr>
          <p:cNvSpPr txBox="1"/>
          <p:nvPr/>
        </p:nvSpPr>
        <p:spPr>
          <a:xfrm>
            <a:off x="7874671" y="2090523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D803889D-810B-0CAC-151D-C5C193533C99}"/>
              </a:ext>
            </a:extLst>
          </p:cNvPr>
          <p:cNvSpPr txBox="1"/>
          <p:nvPr/>
        </p:nvSpPr>
        <p:spPr>
          <a:xfrm>
            <a:off x="9890404" y="256148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B5154D99-71E8-88A4-EA73-B1CF50AF759E}"/>
              </a:ext>
            </a:extLst>
          </p:cNvPr>
          <p:cNvSpPr txBox="1"/>
          <p:nvPr/>
        </p:nvSpPr>
        <p:spPr>
          <a:xfrm>
            <a:off x="3293146" y="5969241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3F112B4-6EE6-A898-B336-DB04E6B93DC1}"/>
              </a:ext>
            </a:extLst>
          </p:cNvPr>
          <p:cNvSpPr txBox="1"/>
          <p:nvPr/>
        </p:nvSpPr>
        <p:spPr>
          <a:xfrm>
            <a:off x="6798346" y="5404100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1553045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9C1E2DFD-D46B-E3F4-5117-9A15BA5E74B2}"/>
              </a:ext>
            </a:extLst>
          </p:cNvPr>
          <p:cNvSpPr txBox="1"/>
          <p:nvPr/>
        </p:nvSpPr>
        <p:spPr>
          <a:xfrm>
            <a:off x="260915" y="1176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55A06D41-9D64-99BC-3C00-9B84B88BCF8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65" t="67727" r="69341" b="18056"/>
          <a:stretch/>
        </p:blipFill>
        <p:spPr>
          <a:xfrm rot="5400000">
            <a:off x="940375" y="1379021"/>
            <a:ext cx="405710" cy="10548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04F33DA-CA00-BA58-3789-B30A125797C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284" t="54676" r="51122" b="31107"/>
          <a:stretch/>
        </p:blipFill>
        <p:spPr>
          <a:xfrm rot="5400000">
            <a:off x="939798" y="480142"/>
            <a:ext cx="405710" cy="10548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38BD688-FA97-BCAB-8142-354459DE2E6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98" t="54598" r="51888" b="31267"/>
          <a:stretch/>
        </p:blipFill>
        <p:spPr>
          <a:xfrm rot="5400000">
            <a:off x="939798" y="1828461"/>
            <a:ext cx="405710" cy="10548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3D24F87-3C76-E0E8-2DDA-DDF7A2BB711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44" t="54049" r="68842" b="31816"/>
          <a:stretch/>
        </p:blipFill>
        <p:spPr>
          <a:xfrm rot="5400000">
            <a:off x="939798" y="929582"/>
            <a:ext cx="405710" cy="10548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C290B3BD-0A44-0362-DBB8-E0A695E8B4C9}"/>
              </a:ext>
            </a:extLst>
          </p:cNvPr>
          <p:cNvSpPr txBox="1"/>
          <p:nvPr/>
        </p:nvSpPr>
        <p:spPr>
          <a:xfrm>
            <a:off x="542105" y="2536313"/>
            <a:ext cx="13083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KO HeLa 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E737DE3-849D-34D9-C58F-0D78706AD23D}"/>
              </a:ext>
            </a:extLst>
          </p:cNvPr>
          <p:cNvSpPr txBox="1"/>
          <p:nvPr/>
        </p:nvSpPr>
        <p:spPr>
          <a:xfrm>
            <a:off x="587696" y="235454"/>
            <a:ext cx="6739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BCB7A689-3D57-CCCA-E599-4749889D0243}"/>
              </a:ext>
            </a:extLst>
          </p:cNvPr>
          <p:cNvCxnSpPr>
            <a:cxnSpLocks/>
          </p:cNvCxnSpPr>
          <p:nvPr/>
        </p:nvCxnSpPr>
        <p:spPr>
          <a:xfrm flipV="1">
            <a:off x="677075" y="445057"/>
            <a:ext cx="438541" cy="24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C784E03C-5E3E-FF00-E81A-57BB7406FC8B}"/>
              </a:ext>
            </a:extLst>
          </p:cNvPr>
          <p:cNvSpPr txBox="1"/>
          <p:nvPr/>
        </p:nvSpPr>
        <p:spPr>
          <a:xfrm>
            <a:off x="1123670" y="238449"/>
            <a:ext cx="6563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FA0CAF0-A0C5-5E52-852B-E949F1B4F1EA}"/>
              </a:ext>
            </a:extLst>
          </p:cNvPr>
          <p:cNvCxnSpPr>
            <a:cxnSpLocks/>
          </p:cNvCxnSpPr>
          <p:nvPr/>
        </p:nvCxnSpPr>
        <p:spPr>
          <a:xfrm flipV="1">
            <a:off x="1195840" y="445057"/>
            <a:ext cx="438541" cy="241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BE45E9A5-8B22-844E-AD89-C15E744CCC0C}"/>
              </a:ext>
            </a:extLst>
          </p:cNvPr>
          <p:cNvSpPr txBox="1"/>
          <p:nvPr/>
        </p:nvSpPr>
        <p:spPr>
          <a:xfrm>
            <a:off x="1601715" y="570839"/>
            <a:ext cx="9476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E8F4581-C58D-D2D5-0B4E-2CC5A6E4C5F0}"/>
              </a:ext>
            </a:extLst>
          </p:cNvPr>
          <p:cNvSpPr txBox="1"/>
          <p:nvPr/>
        </p:nvSpPr>
        <p:spPr>
          <a:xfrm>
            <a:off x="1601715" y="427253"/>
            <a:ext cx="8980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gRNA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4DCBB8AE-D8CF-C86B-76CB-C3A196217DFC}"/>
              </a:ext>
            </a:extLst>
          </p:cNvPr>
          <p:cNvGrpSpPr/>
          <p:nvPr/>
        </p:nvGrpSpPr>
        <p:grpSpPr>
          <a:xfrm>
            <a:off x="630945" y="424645"/>
            <a:ext cx="1012178" cy="365781"/>
            <a:chOff x="7623314" y="2229395"/>
            <a:chExt cx="1113395" cy="365781"/>
          </a:xfrm>
        </p:grpSpPr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352F2600-2EEF-4CAA-1D42-5B76D919A98F}"/>
                </a:ext>
              </a:extLst>
            </p:cNvPr>
            <p:cNvSpPr txBox="1"/>
            <p:nvPr/>
          </p:nvSpPr>
          <p:spPr>
            <a:xfrm>
              <a:off x="8131631" y="2229395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A0CFB09C-D818-CACB-8A9D-4CBC6E7BFFC0}"/>
                </a:ext>
              </a:extLst>
            </p:cNvPr>
            <p:cNvSpPr txBox="1"/>
            <p:nvPr/>
          </p:nvSpPr>
          <p:spPr>
            <a:xfrm>
              <a:off x="8283002" y="2229395"/>
              <a:ext cx="2771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7785D560-BB92-3290-3FE3-63DA7FE8F579}"/>
                </a:ext>
              </a:extLst>
            </p:cNvPr>
            <p:cNvSpPr txBox="1"/>
            <p:nvPr/>
          </p:nvSpPr>
          <p:spPr>
            <a:xfrm>
              <a:off x="8467900" y="2229395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B58FB093-D627-BF06-A935-C0E4EA5ECC62}"/>
                </a:ext>
              </a:extLst>
            </p:cNvPr>
            <p:cNvSpPr txBox="1"/>
            <p:nvPr/>
          </p:nvSpPr>
          <p:spPr>
            <a:xfrm>
              <a:off x="8131631" y="2364344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2A6112F-932C-549C-565B-55953AC907A7}"/>
                </a:ext>
              </a:extLst>
            </p:cNvPr>
            <p:cNvSpPr txBox="1"/>
            <p:nvPr/>
          </p:nvSpPr>
          <p:spPr>
            <a:xfrm>
              <a:off x="8299766" y="2364344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7D2E5A3-9E8E-819E-4047-A6D8EE3A3529}"/>
                </a:ext>
              </a:extLst>
            </p:cNvPr>
            <p:cNvSpPr txBox="1"/>
            <p:nvPr/>
          </p:nvSpPr>
          <p:spPr>
            <a:xfrm>
              <a:off x="8459518" y="2364344"/>
              <a:ext cx="2771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317EB78-2441-3A7A-3432-30FD4D9BC658}"/>
                </a:ext>
              </a:extLst>
            </p:cNvPr>
            <p:cNvSpPr txBox="1"/>
            <p:nvPr/>
          </p:nvSpPr>
          <p:spPr>
            <a:xfrm>
              <a:off x="7623314" y="2229395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B1D1354B-A40D-4F34-2376-36CA2BC8379D}"/>
                </a:ext>
              </a:extLst>
            </p:cNvPr>
            <p:cNvSpPr txBox="1"/>
            <p:nvPr/>
          </p:nvSpPr>
          <p:spPr>
            <a:xfrm>
              <a:off x="7774685" y="2229395"/>
              <a:ext cx="2771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40CA74F8-DE77-9EA6-0E57-E0BA54A280FC}"/>
                </a:ext>
              </a:extLst>
            </p:cNvPr>
            <p:cNvSpPr txBox="1"/>
            <p:nvPr/>
          </p:nvSpPr>
          <p:spPr>
            <a:xfrm>
              <a:off x="7959583" y="2229395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FF2DEE6F-1055-BDC1-9715-4E16D8225AEB}"/>
                </a:ext>
              </a:extLst>
            </p:cNvPr>
            <p:cNvSpPr txBox="1"/>
            <p:nvPr/>
          </p:nvSpPr>
          <p:spPr>
            <a:xfrm>
              <a:off x="7623314" y="2364344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F1B7EBA-A10D-2B2A-1EE0-4560402B1825}"/>
                </a:ext>
              </a:extLst>
            </p:cNvPr>
            <p:cNvSpPr txBox="1"/>
            <p:nvPr/>
          </p:nvSpPr>
          <p:spPr>
            <a:xfrm>
              <a:off x="7791449" y="2364344"/>
              <a:ext cx="24545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46392686-C014-2E9D-7892-999CDD0CB6AB}"/>
                </a:ext>
              </a:extLst>
            </p:cNvPr>
            <p:cNvSpPr txBox="1"/>
            <p:nvPr/>
          </p:nvSpPr>
          <p:spPr>
            <a:xfrm>
              <a:off x="7951198" y="2364344"/>
              <a:ext cx="27719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63" name="TextBox 62">
            <a:extLst>
              <a:ext uri="{FF2B5EF4-FFF2-40B4-BE49-F238E27FC236}">
                <a16:creationId xmlns:a16="http://schemas.microsoft.com/office/drawing/2014/main" id="{0233EEBB-4C1A-BC89-75F7-2713FD2B8925}"/>
              </a:ext>
            </a:extLst>
          </p:cNvPr>
          <p:cNvSpPr txBox="1"/>
          <p:nvPr/>
        </p:nvSpPr>
        <p:spPr>
          <a:xfrm>
            <a:off x="1634363" y="1389492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CDC03E3-02C5-8DB0-37AA-86768D3A11AE}"/>
              </a:ext>
            </a:extLst>
          </p:cNvPr>
          <p:cNvSpPr txBox="1"/>
          <p:nvPr/>
        </p:nvSpPr>
        <p:spPr>
          <a:xfrm>
            <a:off x="1634363" y="1806300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6D501FA-2290-A187-5687-A84815ED5C0D}"/>
              </a:ext>
            </a:extLst>
          </p:cNvPr>
          <p:cNvSpPr txBox="1"/>
          <p:nvPr/>
        </p:nvSpPr>
        <p:spPr>
          <a:xfrm>
            <a:off x="1634363" y="2244134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A50B187-651C-4E6F-E547-896C50931ED5}"/>
              </a:ext>
            </a:extLst>
          </p:cNvPr>
          <p:cNvSpPr txBox="1"/>
          <p:nvPr/>
        </p:nvSpPr>
        <p:spPr>
          <a:xfrm>
            <a:off x="1634363" y="869308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ADF7443-5BD2-CEF2-EF6E-C15DF8027825}"/>
              </a:ext>
            </a:extLst>
          </p:cNvPr>
          <p:cNvSpPr txBox="1"/>
          <p:nvPr/>
        </p:nvSpPr>
        <p:spPr>
          <a:xfrm>
            <a:off x="200025" y="555094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EA804D4-AD41-A846-5595-3163841879A1}"/>
              </a:ext>
            </a:extLst>
          </p:cNvPr>
          <p:cNvSpPr txBox="1"/>
          <p:nvPr/>
        </p:nvSpPr>
        <p:spPr>
          <a:xfrm>
            <a:off x="209627" y="761421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200A7F8-DC37-1BDE-46EE-5A7F0A25047B}"/>
              </a:ext>
            </a:extLst>
          </p:cNvPr>
          <p:cNvSpPr txBox="1"/>
          <p:nvPr/>
        </p:nvSpPr>
        <p:spPr>
          <a:xfrm>
            <a:off x="257802" y="1325027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73386EFC-0AB0-5DA5-DBA5-891B73F91EA4}"/>
              </a:ext>
            </a:extLst>
          </p:cNvPr>
          <p:cNvSpPr txBox="1"/>
          <p:nvPr/>
        </p:nvSpPr>
        <p:spPr>
          <a:xfrm>
            <a:off x="257802" y="2378585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52C1983-C540-ACB3-ACBD-C7E97B244E8C}"/>
              </a:ext>
            </a:extLst>
          </p:cNvPr>
          <p:cNvSpPr txBox="1"/>
          <p:nvPr/>
        </p:nvSpPr>
        <p:spPr>
          <a:xfrm>
            <a:off x="257802" y="1796613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4B8F1EB3-569E-7C77-3C05-E8E350121EB9}"/>
              </a:ext>
            </a:extLst>
          </p:cNvPr>
          <p:cNvCxnSpPr/>
          <p:nvPr/>
        </p:nvCxnSpPr>
        <p:spPr>
          <a:xfrm>
            <a:off x="511082" y="87904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D079201A-B8E8-7D36-EDB2-90672A490852}"/>
              </a:ext>
            </a:extLst>
          </p:cNvPr>
          <p:cNvCxnSpPr/>
          <p:nvPr/>
        </p:nvCxnSpPr>
        <p:spPr>
          <a:xfrm>
            <a:off x="511082" y="1435349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CC3923CC-E266-F9BF-3BEF-282976A23A1E}"/>
              </a:ext>
            </a:extLst>
          </p:cNvPr>
          <p:cNvCxnSpPr/>
          <p:nvPr/>
        </p:nvCxnSpPr>
        <p:spPr>
          <a:xfrm>
            <a:off x="511082" y="1907980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00F8B01B-DD9D-7205-8A05-B3667191265B}"/>
              </a:ext>
            </a:extLst>
          </p:cNvPr>
          <p:cNvCxnSpPr/>
          <p:nvPr/>
        </p:nvCxnSpPr>
        <p:spPr>
          <a:xfrm>
            <a:off x="511082" y="2500178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" name="Picture 1">
            <a:extLst>
              <a:ext uri="{FF2B5EF4-FFF2-40B4-BE49-F238E27FC236}">
                <a16:creationId xmlns:a16="http://schemas.microsoft.com/office/drawing/2014/main" id="{3B7C9AE5-D897-7F4B-DA74-E4856ACBF7A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8" t="-225" r="1035" b="477"/>
          <a:stretch/>
        </p:blipFill>
        <p:spPr>
          <a:xfrm rot="5400000">
            <a:off x="3333024" y="-428954"/>
            <a:ext cx="2951679" cy="41776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C253DD16-1438-F84D-76B4-1D7F362FB68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4" t="-28" r="-655" b="89"/>
          <a:stretch/>
        </p:blipFill>
        <p:spPr>
          <a:xfrm rot="5400000">
            <a:off x="7949227" y="-741230"/>
            <a:ext cx="2351216" cy="4209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9" name="Rectangle 88">
            <a:extLst>
              <a:ext uri="{FF2B5EF4-FFF2-40B4-BE49-F238E27FC236}">
                <a16:creationId xmlns:a16="http://schemas.microsoft.com/office/drawing/2014/main" id="{460CDA59-10F9-3EE8-6E0E-66E3B698F291}"/>
              </a:ext>
            </a:extLst>
          </p:cNvPr>
          <p:cNvSpPr/>
          <p:nvPr/>
        </p:nvSpPr>
        <p:spPr>
          <a:xfrm>
            <a:off x="3970851" y="1404189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24E43C16-AB1D-2687-9ABB-02B60485CC3E}"/>
              </a:ext>
            </a:extLst>
          </p:cNvPr>
          <p:cNvSpPr/>
          <p:nvPr/>
        </p:nvSpPr>
        <p:spPr>
          <a:xfrm>
            <a:off x="8294084" y="655477"/>
            <a:ext cx="662577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0E0C5727-565C-D3DB-75EC-623FB431E9A6}"/>
              </a:ext>
            </a:extLst>
          </p:cNvPr>
          <p:cNvSpPr/>
          <p:nvPr/>
        </p:nvSpPr>
        <p:spPr>
          <a:xfrm>
            <a:off x="8319498" y="1072968"/>
            <a:ext cx="662577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DB013117-B864-926A-7A1E-1F8FBE589384}"/>
              </a:ext>
            </a:extLst>
          </p:cNvPr>
          <p:cNvSpPr/>
          <p:nvPr/>
        </p:nvSpPr>
        <p:spPr>
          <a:xfrm>
            <a:off x="3495242" y="848081"/>
            <a:ext cx="568339" cy="25205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AA6BADB0-EE2A-FF71-A5CB-DC4FA432AD75}"/>
              </a:ext>
            </a:extLst>
          </p:cNvPr>
          <p:cNvSpPr txBox="1"/>
          <p:nvPr/>
        </p:nvSpPr>
        <p:spPr>
          <a:xfrm>
            <a:off x="4542031" y="1392241"/>
            <a:ext cx="55015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2C4D93C-F088-ACCA-90CF-0FE8F56B53E5}"/>
              </a:ext>
            </a:extLst>
          </p:cNvPr>
          <p:cNvSpPr txBox="1"/>
          <p:nvPr/>
        </p:nvSpPr>
        <p:spPr>
          <a:xfrm>
            <a:off x="9050766" y="617249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54EBC2D7-B4C3-05B2-E5CB-74AB92D76F77}"/>
              </a:ext>
            </a:extLst>
          </p:cNvPr>
          <p:cNvSpPr txBox="1"/>
          <p:nvPr/>
        </p:nvSpPr>
        <p:spPr>
          <a:xfrm>
            <a:off x="3531591" y="635026"/>
            <a:ext cx="54053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2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1A2A3BE-ECB4-3C63-7320-7BCACDEC3AE2}"/>
              </a:ext>
            </a:extLst>
          </p:cNvPr>
          <p:cNvSpPr txBox="1"/>
          <p:nvPr/>
        </p:nvSpPr>
        <p:spPr>
          <a:xfrm>
            <a:off x="9085834" y="1023318"/>
            <a:ext cx="5453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506556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9</Words>
  <Application>Microsoft Office PowerPoint</Application>
  <PresentationFormat>Widescreen</PresentationFormat>
  <Paragraphs>6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5-20T08:04:49Z</dcterms:created>
  <dcterms:modified xsi:type="dcterms:W3CDTF">2024-05-20T08:11:11Z</dcterms:modified>
</cp:coreProperties>
</file>